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2" r:id="rId2"/>
    <p:sldId id="256" r:id="rId3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>
        <p:scale>
          <a:sx n="84" d="100"/>
          <a:sy n="84" d="100"/>
        </p:scale>
        <p:origin x="-276" y="18"/>
      </p:cViewPr>
      <p:guideLst>
        <p:guide orient="horz" pos="2917"/>
        <p:guide pos="1748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DDD445-9B08-0F49-9923-71E6AE8028F6}" type="datetimeFigureOut">
              <a:rPr lang="en-US" smtClean="0"/>
              <a:t>5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5D661-547E-5C49-99AA-32A316B93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84120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DDD445-9B08-0F49-9923-71E6AE8028F6}" type="datetimeFigureOut">
              <a:rPr lang="en-US" smtClean="0"/>
              <a:t>5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5D661-547E-5C49-99AA-32A316B93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7074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DDD445-9B08-0F49-9923-71E6AE8028F6}" type="datetimeFigureOut">
              <a:rPr lang="en-US" smtClean="0"/>
              <a:t>5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5D661-547E-5C49-99AA-32A316B93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42118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DDD445-9B08-0F49-9923-71E6AE8028F6}" type="datetimeFigureOut">
              <a:rPr lang="en-US" smtClean="0"/>
              <a:t>5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5D661-547E-5C49-99AA-32A316B93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28036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DDD445-9B08-0F49-9923-71E6AE8028F6}" type="datetimeFigureOut">
              <a:rPr lang="en-US" smtClean="0"/>
              <a:t>5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5D661-547E-5C49-99AA-32A316B93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8688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DDD445-9B08-0F49-9923-71E6AE8028F6}" type="datetimeFigureOut">
              <a:rPr lang="en-US" smtClean="0"/>
              <a:t>5/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5D661-547E-5C49-99AA-32A316B93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0657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DDD445-9B08-0F49-9923-71E6AE8028F6}" type="datetimeFigureOut">
              <a:rPr lang="en-US" smtClean="0"/>
              <a:t>5/1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5D661-547E-5C49-99AA-32A316B93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59646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DDD445-9B08-0F49-9923-71E6AE8028F6}" type="datetimeFigureOut">
              <a:rPr lang="en-US" smtClean="0"/>
              <a:t>5/1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5D661-547E-5C49-99AA-32A316B93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51783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DDD445-9B08-0F49-9923-71E6AE8028F6}" type="datetimeFigureOut">
              <a:rPr lang="en-US" smtClean="0"/>
              <a:t>5/1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5D661-547E-5C49-99AA-32A316B93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19658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DDD445-9B08-0F49-9923-71E6AE8028F6}" type="datetimeFigureOut">
              <a:rPr lang="en-US" smtClean="0"/>
              <a:t>5/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5D661-547E-5C49-99AA-32A316B93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06026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DDD445-9B08-0F49-9923-71E6AE8028F6}" type="datetimeFigureOut">
              <a:rPr lang="en-US" smtClean="0"/>
              <a:t>5/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5D661-547E-5C49-99AA-32A316B93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84466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DDD445-9B08-0F49-9923-71E6AE8028F6}" type="datetimeFigureOut">
              <a:rPr lang="en-US" smtClean="0"/>
              <a:t>5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35D661-547E-5C49-99AA-32A316B93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18557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Cluster_on_BLCA_SigMuts_v1.tiff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97122"/>
          <a:stretch/>
        </p:blipFill>
        <p:spPr>
          <a:xfrm>
            <a:off x="1292544" y="119138"/>
            <a:ext cx="3262838" cy="354811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/>
          <a:srcRect l="13585" r="3516"/>
          <a:stretch/>
        </p:blipFill>
        <p:spPr>
          <a:xfrm rot="16200000">
            <a:off x="2503327" y="5263718"/>
            <a:ext cx="1211082" cy="2662110"/>
          </a:xfrm>
          <a:prstGeom prst="rect">
            <a:avLst/>
          </a:prstGeom>
        </p:spPr>
      </p:pic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181429" y="75904"/>
            <a:ext cx="6579809" cy="407911"/>
          </a:xfrm>
        </p:spPr>
        <p:txBody>
          <a:bodyPr>
            <a:noAutofit/>
          </a:bodyPr>
          <a:lstStyle/>
          <a:p>
            <a:pPr algn="l"/>
            <a:r>
              <a:rPr lang="en-US" sz="1400" b="1" dirty="0" smtClean="0"/>
              <a:t>SI-II</a:t>
            </a:r>
            <a:r>
              <a:rPr lang="en-US" sz="1400" dirty="0" smtClean="0"/>
              <a:t>	</a:t>
            </a:r>
            <a:r>
              <a:rPr lang="en-US" sz="1400" dirty="0" smtClean="0"/>
              <a:t>A</a:t>
            </a:r>
            <a:r>
              <a:rPr lang="en-US" sz="1400" dirty="0" smtClean="0"/>
              <a:t>								</a:t>
            </a:r>
            <a:endParaRPr lang="en-US" sz="1400" dirty="0"/>
          </a:p>
        </p:txBody>
      </p:sp>
      <p:sp>
        <p:nvSpPr>
          <p:cNvPr id="3" name="TextBox 2"/>
          <p:cNvSpPr txBox="1"/>
          <p:nvPr/>
        </p:nvSpPr>
        <p:spPr>
          <a:xfrm>
            <a:off x="274607" y="7308652"/>
            <a:ext cx="5000118" cy="17543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-II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analysis of bladder cancer functionally active genes and significantly mutated genes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rehensiv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anscriptom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filing of the P0 PDX tumors was performed with RNA-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q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alysis. Relative expression was determined by hierarchical clustering of the gene-level FPKM data.</a:t>
            </a:r>
            <a:endParaRPr lang="en-US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. Relative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of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ladder cancer functionally active genes and significantly mutated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s.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results are shown as heat maps with the following color scheme: blue = lower than the mean, red = greater than the mean, white = mean. The datasets used for each panel are presented in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s 4 and 5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 descr="Cluster_on_BLCA_SigMuts_v1.tiff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782"/>
          <a:stretch/>
        </p:blipFill>
        <p:spPr>
          <a:xfrm>
            <a:off x="1402533" y="430306"/>
            <a:ext cx="3131855" cy="5566715"/>
          </a:xfrm>
          <a:prstGeom prst="rect">
            <a:avLst/>
          </a:prstGeom>
        </p:spPr>
      </p:pic>
      <p:pic>
        <p:nvPicPr>
          <p:cNvPr id="8" name="Picture 7" descr="Cluster_on_BLCA_SigMuts_v1.tiff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2826" t="88187"/>
          <a:stretch/>
        </p:blipFill>
        <p:spPr>
          <a:xfrm>
            <a:off x="494781" y="3426399"/>
            <a:ext cx="457001" cy="2843576"/>
          </a:xfrm>
          <a:prstGeom prst="rect">
            <a:avLst/>
          </a:prstGeom>
        </p:spPr>
      </p:pic>
      <p:pic>
        <p:nvPicPr>
          <p:cNvPr id="9" name="Picture 8" descr="Cluster_on_BLCA_SigMuts_v1.tiff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2811" t="38233" r="1333" b="25598"/>
          <a:stretch/>
        </p:blipFill>
        <p:spPr>
          <a:xfrm>
            <a:off x="5504188" y="187526"/>
            <a:ext cx="329713" cy="7414527"/>
          </a:xfrm>
          <a:prstGeom prst="rect">
            <a:avLst/>
          </a:prstGeom>
        </p:spPr>
      </p:pic>
      <p:cxnSp>
        <p:nvCxnSpPr>
          <p:cNvPr id="10" name="Straight Connector 9"/>
          <p:cNvCxnSpPr/>
          <p:nvPr/>
        </p:nvCxnSpPr>
        <p:spPr>
          <a:xfrm flipH="1" flipV="1">
            <a:off x="4484077" y="4523154"/>
            <a:ext cx="1035661" cy="303907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 flipH="1">
            <a:off x="4416583" y="221390"/>
            <a:ext cx="1103155" cy="215828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 flipH="1" flipV="1">
            <a:off x="746226" y="3362028"/>
            <a:ext cx="925420" cy="194219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 flipH="1" flipV="1">
            <a:off x="715555" y="5981708"/>
            <a:ext cx="920639" cy="1147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176032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181429" y="75904"/>
            <a:ext cx="6579809" cy="407911"/>
          </a:xfrm>
        </p:spPr>
        <p:txBody>
          <a:bodyPr>
            <a:noAutofit/>
          </a:bodyPr>
          <a:lstStyle/>
          <a:p>
            <a:pPr algn="l"/>
            <a:r>
              <a:rPr lang="en-US" sz="1400" b="1" dirty="0" smtClean="0"/>
              <a:t>SI-II.</a:t>
            </a:r>
            <a:r>
              <a:rPr lang="en-US" sz="1400" dirty="0" smtClean="0"/>
              <a:t> 									</a:t>
            </a:r>
            <a:endParaRPr lang="en-US" sz="1400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-1457786" y="2529015"/>
            <a:ext cx="7752566" cy="383843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12559" y="396875"/>
            <a:ext cx="2872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B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4221125" y="4189228"/>
            <a:ext cx="2349795" cy="37856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-II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analysis of bladder cancer functionally active genes and significantly mutated genes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rehensiv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anscriptom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filing of the P0 PDX tumors was performed with RNA-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q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alysis. Relative expression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s determined by hierarchical clustering of the gene-level FPKM data. </a:t>
            </a:r>
            <a:endParaRPr lang="en-US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. Relative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n-cancer driver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s.</a:t>
            </a: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ults are shown as heat maps with the following color scheme: blue = lower than the mean, red = greater than the mean, white = mean. The datasets used for each panel are presented in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s 4 and 5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865001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513</TotalTime>
  <Words>204</Words>
  <Application>Microsoft Office PowerPoint</Application>
  <PresentationFormat>Letter Paper (8.5x11 in)</PresentationFormat>
  <Paragraphs>9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SI-II A        </vt:lpstr>
      <vt:lpstr>SI-II.          </vt:lpstr>
    </vt:vector>
  </TitlesOfParts>
  <Company>UC Davis School of Medicin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1A.          BLCA_PDX_Manuscript</dc:title>
  <dc:creator>Clifford Tepper</dc:creator>
  <cp:lastModifiedBy>ntwadmin</cp:lastModifiedBy>
  <cp:revision>88</cp:revision>
  <cp:lastPrinted>2015-04-30T09:21:43Z</cp:lastPrinted>
  <dcterms:created xsi:type="dcterms:W3CDTF">2013-12-19T20:23:54Z</dcterms:created>
  <dcterms:modified xsi:type="dcterms:W3CDTF">2015-05-01T21:10:56Z</dcterms:modified>
</cp:coreProperties>
</file>